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-325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916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69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3755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7835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106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345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9685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20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0913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938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186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D33E9-5BD6-4F94-9A4A-B37B533B9ADA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F89F9-4DE7-4599-BFBD-08282EBDCD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632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5861"/>
            <a:ext cx="6858000" cy="809227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20538" y="0"/>
            <a:ext cx="22407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ry Figure 3</a:t>
            </a:r>
            <a:endParaRPr lang="en-GB" sz="11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912686" y="7564799"/>
            <a:ext cx="744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5_all</a:t>
            </a:r>
            <a:endParaRPr lang="en-GB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773225" y="6941001"/>
            <a:ext cx="883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1_birds</a:t>
            </a:r>
            <a:endParaRPr lang="en-GB" sz="1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773225" y="6747779"/>
            <a:ext cx="883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2_birds</a:t>
            </a:r>
            <a:endParaRPr lang="en-GB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773225" y="6375320"/>
            <a:ext cx="883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3_birds</a:t>
            </a:r>
            <a:endParaRPr lang="en-GB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386901" y="2429917"/>
            <a:ext cx="12698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123_mammals</a:t>
            </a:r>
            <a:endParaRPr lang="en-GB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846963" y="5469061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/>
              <a:t>IFITM10_all</a:t>
            </a:r>
            <a:endParaRPr lang="en-GB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220244" y="8204641"/>
            <a:ext cx="1053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IFITMs_xenopus</a:t>
            </a:r>
            <a:endParaRPr lang="en-GB" sz="1000" b="1" dirty="0"/>
          </a:p>
        </p:txBody>
      </p:sp>
    </p:spTree>
    <p:extLst>
      <p:ext uri="{BB962C8B-B14F-4D97-AF65-F5344CB8AC3E}">
        <p14:creationId xmlns:p14="http://schemas.microsoft.com/office/powerpoint/2010/main" val="1584029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 Jacqueline</dc:creator>
  <cp:lastModifiedBy>BURT</cp:lastModifiedBy>
  <cp:revision>14</cp:revision>
  <cp:lastPrinted>2014-08-14T12:45:37Z</cp:lastPrinted>
  <dcterms:created xsi:type="dcterms:W3CDTF">2013-06-12T13:46:10Z</dcterms:created>
  <dcterms:modified xsi:type="dcterms:W3CDTF">2014-08-15T12:10:13Z</dcterms:modified>
</cp:coreProperties>
</file>